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media/image1.tif" ContentType="image/tif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</p:sldMasterIdLst>
  <p:sldIdLst>
    <p:sldId id="256" r:id="rId14"/>
    <p:sldId id="257" r:id="rId1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" Target="slides/slide1.xml"/><Relationship Id="rId15" Type="http://schemas.openxmlformats.org/officeDocument/2006/relationships/slide" Target="slides/slide2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A4296-96E5-4EDF-B145-B801E2EC1A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03E77E-0B6E-47CD-9B89-172719CDD9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F736AE2-90A2-47AB-AC88-592F6E6796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22CBA983-1DDD-4605-B2BD-EA0DC8DCA4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FC3470AA-57A1-4DD2-B03D-0BB58F4A44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792D173-B411-4D73-92CA-69B86D1BB4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67D00D8-EE6A-48BA-AA8E-8F520AA6C9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51D04A1-B2CC-45DA-AB00-113B32CDF8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7FAE200-1B02-498B-B6F6-D1B5C1E068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FFB78386-194C-49B5-8D98-6CE9E6F3C1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6DB93AE-DC66-491A-B573-8880131C54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0BCFC97-E838-422A-A86C-226989546C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360D48-F6FF-498B-A8EF-22BCD3D9CF7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9FE6DFE3-7412-45B1-8D0A-A5EA7D64B1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712122A-434F-45C0-BF34-BD2AE1E1C8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12493CD-5A88-4B9B-BF24-73734827E4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3D844E0-D8DD-42FE-AF81-D475941D93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A1CC99E-7EBC-468E-B124-E29F826E34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C01BC6A-523C-40C9-9B06-E5BE0A691E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3BE9B3C-5022-48AC-AFBA-6C429013B7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4DA18A7-7C2A-404C-915D-1968D49436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74B9626-4419-4CC2-8349-836787BFD5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E006ED0-1A08-4BCD-9A6F-ADBCCAE653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628BD6-874A-4888-9408-AA3E7D3712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62E0B12C-43DD-47AA-9183-5797E3E25C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B3B49A5-8769-498F-AE32-134D0E330A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7588E35-509C-485C-BEBF-1B17D50F63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CFB919E-7555-4D1E-8DFE-B426907224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FD9CEF00-1788-4022-A50A-A6E620CFA4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022B8DB-3791-4ECC-A2DB-1A4FD3AA08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661DFBA-0C63-4B3F-B768-8E29BFA19E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72CA12F-7AF5-4E36-90E7-832E416AF7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3B60ED7-067A-464D-8569-3E7B54EADF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E402B57-988B-4CE1-B53E-BD0079525E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498C556-8616-413F-B122-B1A17384FE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CB481E2-112B-4280-A8A2-3EF5C9C16A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93B37959-FC81-4C7C-99D2-F354C186A44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6C2E42A-2967-4E96-A69C-8F1A153026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2B18B56-71CC-4CDD-97F8-868FD747D3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CFB88FE-F83E-410E-A1E7-48F7ACB01B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E00ACB1-A812-41A8-BC46-DDD990429F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426FAD1-BE20-4041-86DC-D39D5F9DA0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F13F08F-C7B1-47C7-8C7F-887E457590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55B789E0-45E6-4909-802A-CF3B23500D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F67B22C-A3A7-4FDA-9F14-E2CE58E9A8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969B1FA-DD0D-45A2-9E3A-3E12895525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3B28689-D0B8-4344-89C3-ECFE620571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BD8B782-BD54-4FFF-8889-A43AAA10B3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6C94E4A-8B3F-42DE-89E9-44AB3F05FD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AB5FA40-999E-49ED-9087-FA75E80DF3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86BFD323-B0E9-406E-8268-4DBD143063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629BEF0-938C-40BF-A471-C218924CC3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FD7C46E-CCB6-4F9C-AAEB-0545A089C8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6AF785E-EE3E-45F2-A346-D52B99D781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1DFC045-5113-477B-BF46-2CEA2B7234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8C168F3-4883-482C-B9BC-D25FBEC403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8FEAE-5E09-479D-9F8E-480C042BA6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DAA4898-C080-4ACC-B584-E518C9ABA8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F8CBBCD-7F25-4E31-A0CE-3C4927C891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7E46EBB-46EC-4342-9D47-A1296DE32D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F30C930-4414-4DC9-9F1D-10F1E3DB022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BC8110F-5EC4-432F-ABFE-EB4534AA19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5C51BE8-F0EF-45F4-86EF-105B1DE64C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BB21950-036C-4840-ACDE-99FA5565E0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700A2A5-E18C-44AE-8306-D3EB355715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E4787B1-5500-4E71-A93E-9D2ACE3FAA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3BCE19E-7BAA-4503-9140-61986671AD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B3B12-3810-4910-85EC-E454062181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7FFB1EB-3A4B-41A3-A36A-26947AD37A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7F99A57-0C15-48A7-868E-A9E7A5A183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33EAEA7-0EC8-462D-A11A-AA535C3224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E408DDD-32BA-4C5B-B5AE-81240F0D5D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C70A56D-5A59-4275-BC7E-28D2EBCC5F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7D7EC63-C12B-4390-9671-927F1576BA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FF70A07-1DD0-4607-A3BD-530352696E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54ECE73-C133-43FA-B899-492CE7EF43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9641BE8-BB0A-47F4-8D2D-7EE256BCFD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67305AD-E008-47B1-A702-72305E4CE6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86A64-79F9-4628-9CEC-11AB4BDFD5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E0E1DC2-F044-4590-AF43-CEF4F71A29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3757F58-6FD1-401A-8814-145715BBE3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34544B0-5B4B-4B0A-87B8-2E0E701D1A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0BDAB8C-808D-464E-8A15-8D80F79A19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F3E6FA2-8E32-4D76-BE49-F2FECD72CD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455DDFA-098A-4A46-A5C0-8992EF9156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8C60E80-982B-4420-849C-B13792550C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DB4A4AB-A8D2-49E7-B614-503B8D56BF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55CC1A7-985C-4C62-98C6-A7917CC7C1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BAB160B-F530-4F8C-8DF2-F1B19BB746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D155DF-42A3-43C9-A412-74728A0E73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74290F0-BABA-49C0-83AA-C52AB01351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8402331-F5FC-49FC-8C4C-366F1089B0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25CBC09-C066-4457-B57F-CE76FD30F2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E190942-F763-4B14-A0EB-F81E574D30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D6C15C5-E058-4334-AB17-C2F24CD6AD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400C12A-655C-4813-8372-32E4BF93B1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5555713-4B3A-45B9-8E29-B12B1F55DD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F106E73-8E94-432E-90AE-9434F46DC0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7E5031B-AAEB-424B-B4B9-3D606072D4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4B1BC9A-E0CC-4E3D-AE76-2777DDC637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AC4BB2-4869-4C30-B993-E8768E2D0A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115D471-73DB-477B-BABA-B400C2F92F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07E1F17-7A9E-4BC9-9B3A-A3BE77CE67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A1324F4-7B18-4F72-A058-442F2728BE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36CADBD-9602-4A6B-9581-BEF1E8794C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5458DAB-C62B-4D44-A3BD-E12E726518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36F6963-9A3E-4E5A-93B3-FE65946606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33463B3-7629-451E-B94F-A929AD51A6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C87DF1D-8527-4884-9E86-6C4238EFE6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7290697-4375-4474-9A29-4D9C536952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13B489D-98D5-4E11-8CE8-A47573B64C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3BE29-985B-478F-A3D6-55EDD00C85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6C557EA-D105-4E05-8353-B331E7DEE5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8BE5EDF-6BFF-4095-BBCB-BD354538A1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A1ADF25-D705-49F3-870A-69E742F2F4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C15EB5B-CD56-4E89-BB44-9C9FF45E25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0BABA5F-B1EC-4F32-B302-8C97F5349B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3F17E6B-FA3B-44A3-8379-7B4285622F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66E8069-573A-4524-B46C-61D4136CDC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243DDB1-B346-42C1-AEEB-0511736DCE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7D494AD-1D4C-414C-BD6E-DE862B3CE3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9807C1A-A812-45A7-B946-26ECC5EE26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41826-4647-4F32-8600-6B5E18F772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F5F9BF6E-6663-49F2-83A4-4BF12395C6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0523BDD-88FA-4A36-BC8D-0167804B3E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EAC121E-6738-480C-A229-DD7BF7C0D3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3988FA3-C999-4E1C-A63F-72755E4C98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C9C2512-22D0-445E-9E48-D6E60A752E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2BFAF74-CD4E-4D44-8BA1-78D320B410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EBDED100-45ED-4DAE-A160-048ECFB5A9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8D31022-2364-4046-A2C6-DE17D9671D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D891F5C-F628-41C7-863F-D3E1DB8F19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183B194-9DC7-4F74-974D-B652C08862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5FE4F2-3696-427F-9B7E-D528EDE0AB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1E4ACD9-A445-434F-80DA-FB47DAB3C1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5240888-91C8-4863-9E81-1AB78972E6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A7C26F3-2973-4445-91E3-448481F245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3F2A475-C8D8-44DD-9F13-4749EBCB35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605D248-8020-4E2B-8E0A-9E85DE181C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6D7E2DD-87AE-4F9B-8646-C7A7784A89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F8B5CA1-5DE3-4D49-8650-2553E36FDB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4CB374F-FA4C-4BC0-BCA6-5E73672835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F24D6772-E358-4E62-8D3D-734A85C63C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FF7C9F7-68BA-470D-995B-4C45F40561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D97109-07B8-4354-AD9C-01C37BC64875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F3C9F2-0A15-4F67-B06F-5D64750F0B51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42ABF6-33C6-4645-81E8-3E0EFD806D5B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07369D-2469-4C38-AAD4-730864DF4718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0505E7-98BB-481A-9BB0-AF1F0A1644C0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FBF9FC-3CE4-4E8A-B989-CDE464BFB475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6DFC12-A715-4A9D-887E-17C37BCAE269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2FD84C-C07E-492F-97D5-E1C4D5F1F210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22CC5D-5F6C-4A8B-BC53-0E22AEA8348A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81637A-50E3-402F-AD0D-8118DA412700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FD64FC-871C-4220-ACA9-219EDC1BD725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Times New Roman"/>
                <a:ea typeface="宋体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A44F18-3AB4-47AA-AA18-8560B17BBF7D}" type="slidenum">
              <a:rPr b="0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2" name="图片 2" descr="Fig. S1-无图层-5.26"/>
          <p:cNvPicPr/>
          <p:nvPr/>
        </p:nvPicPr>
        <p:blipFill>
          <a:blip r:embed="rId1"/>
          <a:srcRect l="-8042" t="0" r="0" b="33348"/>
          <a:stretch/>
        </p:blipFill>
        <p:spPr>
          <a:xfrm>
            <a:off x="1835280" y="517680"/>
            <a:ext cx="5572080" cy="6222960"/>
          </a:xfrm>
          <a:prstGeom prst="rect">
            <a:avLst/>
          </a:prstGeom>
          <a:ln w="0">
            <a:noFill/>
          </a:ln>
        </p:spPr>
      </p:pic>
      <p:sp>
        <p:nvSpPr>
          <p:cNvPr id="493" name="文本框 99"/>
          <p:cNvSpPr/>
          <p:nvPr/>
        </p:nvSpPr>
        <p:spPr>
          <a:xfrm>
            <a:off x="466560" y="171360"/>
            <a:ext cx="508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ure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and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Table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4" name="文本框 3"/>
          <p:cNvSpPr/>
          <p:nvPr/>
        </p:nvSpPr>
        <p:spPr>
          <a:xfrm>
            <a:off x="1492200" y="1014480"/>
            <a:ext cx="6162840" cy="307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Supplementary Figure 1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. Em images of the intestines of Sham mice and I/R mice. 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(A)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 Representative transmission electron microscopy (TEM) images in the intestine, n=3. Arrows indicate the AVs, N, nucleus. 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(B)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 Immuno-electron microscopy (IEM) analyses of intestines subjected to Sham and I/R. The localization of endogenous LC3 was visualized with specific antibodies and detected with a secondary antibody conjugated to 5-nm collodial gold particles. Arrowheads indicate labeling. One of 3 independent experiments is show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5-26T10:37:46Z</dcterms:created>
  <dc:creator>Administrator</dc:creator>
  <dc:description/>
  <cp:keywords/>
  <dc:language>en-US</dc:language>
  <cp:lastModifiedBy>zhenlu li</cp:lastModifiedBy>
  <dcterms:modified xsi:type="dcterms:W3CDTF">2017-09-25T12:48:26Z</dcterms:modified>
  <cp:revision>7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490</vt:lpwstr>
  </property>
</Properties>
</file>